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26943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Kengn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Ramachandran (2024) Diabetologia DOI 10.1007/s00125-023-06085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teps in the implementation of effective type 2 diabetes prevention </a:t>
            </a:r>
            <a:r>
              <a:rPr lang="en-US" sz="1800" b="1" dirty="0" err="1"/>
              <a:t>programmes</a:t>
            </a:r>
            <a:r>
              <a:rPr lang="en-US" sz="1800" b="1" dirty="0"/>
              <a:t>: the way forward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FD22E77-18D7-3314-902C-DF24980ABB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1680" y="950140"/>
            <a:ext cx="5796444" cy="463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6</cp:revision>
  <dcterms:created xsi:type="dcterms:W3CDTF">2016-06-15T12:53:43Z</dcterms:created>
  <dcterms:modified xsi:type="dcterms:W3CDTF">2024-01-30T14:48:30Z</dcterms:modified>
</cp:coreProperties>
</file>